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3" r:id="rId2"/>
    <p:sldId id="277" r:id="rId3"/>
    <p:sldId id="275" r:id="rId4"/>
    <p:sldId id="262" r:id="rId5"/>
    <p:sldId id="274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47" autoAdjust="0"/>
    <p:restoredTop sz="73653" autoAdjust="0"/>
  </p:normalViewPr>
  <p:slideViewPr>
    <p:cSldViewPr>
      <p:cViewPr varScale="1">
        <p:scale>
          <a:sx n="83" d="100"/>
          <a:sy n="83" d="100"/>
        </p:scale>
        <p:origin x="-2538" y="-84"/>
      </p:cViewPr>
      <p:guideLst>
        <p:guide orient="horz" pos="2160"/>
        <p:guide pos="2880"/>
      </p:guideLst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A91980-9A26-4CC5-81E5-9C0D2028359D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DF12A3-0CC2-4FF5-A577-A49D223CCB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30583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. Figure 1. Immunohistochemistry staining of PD-L1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l tissues were stained with anti-PD-L1 antibody (Abcam, ab205921) and hematoxylin (DAKO, K8002 kit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The scale bar is 100μm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DF12A3-0CC2-4FF5-A577-A49D223CCBD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54341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. Figure 3. Association between</a:t>
            </a:r>
            <a:r>
              <a:rPr lang="en-US" altLang="zh-CN" b="1" baseline="0" dirty="0">
                <a:latin typeface="Arial" panose="020B0604020202020204" pitchFamily="34" charset="0"/>
                <a:cs typeface="Arial" panose="020B0604020202020204" pitchFamily="34" charset="0"/>
              </a:rPr>
              <a:t> bTMB and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linical </a:t>
            </a:r>
            <a:r>
              <a:rPr lang="en-US" altLang="zh-CN" b="1" baseline="0" dirty="0">
                <a:latin typeface="Arial" panose="020B0604020202020204" pitchFamily="34" charset="0"/>
                <a:cs typeface="Arial" panose="020B0604020202020204" pitchFamily="34" charset="0"/>
              </a:rPr>
              <a:t>outcome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he mean bTMB (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TMB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for each patient was not significantly different between the SD/PD outcome and PR outcome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DF12A3-0CC2-4FF5-A577-A49D223CCBDE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38211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. Figure 4. The CT scan results for patient 1 and 8.</a:t>
            </a:r>
            <a:endParaRPr lang="zh-CN" altLang="zh-CN" sz="1200" kern="1200" dirty="0">
              <a:solidFill>
                <a:schemeClr val="tx1"/>
              </a:solidFill>
              <a:effectLst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A)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Metastasis in scapula for patient 1. 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B)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T scan results for patient 8 in primary lung tumor (left column), metastasis around paraspinal (middle column) and liver (right column). Red arrows indicated the tumor positions 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A and B)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</a:t>
            </a:r>
            <a:endParaRPr lang="zh-CN" altLang="zh-CN" sz="1200" kern="1200" dirty="0">
              <a:solidFill>
                <a:schemeClr val="tx1"/>
              </a:solidFill>
              <a:effectLst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DF12A3-0CC2-4FF5-A577-A49D223CCBDE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18636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. Table 1. The 329 ctDNA targeting gene list.</a:t>
            </a:r>
            <a:endParaRPr lang="zh-CN" altLang="zh-CN" sz="1200" kern="1200" dirty="0">
              <a:solidFill>
                <a:schemeClr val="tx1"/>
              </a:solidFill>
              <a:effectLst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DF12A3-0CC2-4FF5-A577-A49D223CCBDE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817864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DF12A3-0CC2-4FF5-A577-A49D223CCBDE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88903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8/15 Thu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1560" y="476672"/>
            <a:ext cx="65527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1. Immunohistochemistry staining of PD-L1.</a:t>
            </a:r>
            <a:endParaRPr lang="zh-CN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1" name="Picture 3" descr="D:\zywhome\zhiben\ResearchTopic\201808\chongq\5.ms\figures\supplement\PD_L1.v2\pd.l1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5" y="1587954"/>
            <a:ext cx="8280072" cy="35692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310775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D:\zywhome\zhiben\ResearchTopic\201808\chongq\5.ms\figures\sup.fig.btmb\g1743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06960" y="1196752"/>
            <a:ext cx="4464496" cy="43990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矩形 3"/>
          <p:cNvSpPr/>
          <p:nvPr/>
        </p:nvSpPr>
        <p:spPr>
          <a:xfrm>
            <a:off x="755576" y="332656"/>
            <a:ext cx="734481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</a:t>
            </a:r>
            <a:r>
              <a:rPr lang="en-US" altLang="zh-C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ssociation between bTMB and clinical outcome</a:t>
            </a:r>
          </a:p>
        </p:txBody>
      </p:sp>
    </p:spTree>
    <p:extLst>
      <p:ext uri="{BB962C8B-B14F-4D97-AF65-F5344CB8AC3E}">
        <p14:creationId xmlns:p14="http://schemas.microsoft.com/office/powerpoint/2010/main" val="2748171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矩形 22"/>
          <p:cNvSpPr/>
          <p:nvPr/>
        </p:nvSpPr>
        <p:spPr>
          <a:xfrm>
            <a:off x="179512" y="692696"/>
            <a:ext cx="561724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600" b="1" smtClean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The CT scan results for patient 1 and 8.</a:t>
            </a:r>
            <a:endParaRPr lang="zh-CN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 descr="D:\zywhome\zhiben\ResearchTopic\201808\chongq\5.ms\figures\fig.pat1_8.ct\pat8.ct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1628800"/>
            <a:ext cx="8183965" cy="41764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245977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7663414"/>
              </p:ext>
            </p:extLst>
          </p:nvPr>
        </p:nvGraphicFramePr>
        <p:xfrm>
          <a:off x="1331640" y="1196752"/>
          <a:ext cx="6235768" cy="4525950"/>
        </p:xfrm>
        <a:graphic>
          <a:graphicData uri="http://schemas.openxmlformats.org/drawingml/2006/table">
            <a:tbl>
              <a:tblPr/>
              <a:tblGrid>
                <a:gridCol w="56688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688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6688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6688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6688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66888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566888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566888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566888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66888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66888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</a:tblGrid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BL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CORL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KN2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GF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GFR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IGF1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DM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R4A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PP2R1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UNX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TAT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BL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C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EBP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GF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GFR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IKZF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ED1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RAS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RDM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UNX1T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TAT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CVR1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LM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FT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P300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H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IL7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EN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RG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REX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DH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TK1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CVR2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MPR1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HD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PHA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LCN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INPP4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ET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RG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RKAC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DH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UFU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KT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RAF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HD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PHA5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LT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ITK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GMT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SD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RKCI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DH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YK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KT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RCA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HEK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PHA7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LT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JAK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LH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SD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RKD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DHD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BX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KT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RCA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HEK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PHB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LT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JAK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PL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TRK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RSS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ETBP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CF7L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LK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RD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I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RBB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OXL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JAK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RE1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TRK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RSS8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ETD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ERT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MER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RIP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OL1A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RBB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OXP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JUN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SH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TRK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TCH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F3B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ET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P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AMTA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RBN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RBB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UBP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KDM5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SH6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UP9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TEN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IK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ET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POBEC3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ARD1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REB3L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RCC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US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KDM5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TO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ALB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TPN1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LIT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FE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ASP8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REBBP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RRFI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YN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KDM6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UTYH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ARK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QKI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MAD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GFBR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RAF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BL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RKL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SR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GATA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KD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Y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ARP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AC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MAD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GFBR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RID1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CND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RLF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TV6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GATA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KEAP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YCL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ARP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AD50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MAD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OP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RID1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CND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SF1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EZH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GATA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KIT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YCN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AX5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AD5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MARCA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OP2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RID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CND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SK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M135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GATA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KMT2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YD88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BRM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AD51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MARCB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P5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SXL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CNE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SNK1A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M46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GLI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KMT2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BN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DCD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AF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MO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P6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TM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27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TCF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NC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GLI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KMT2D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COA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DCD1LG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ANBP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NCAIP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SC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T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79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TNNA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NC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GNA1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KRAS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COR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DGFR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AR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ND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SC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TRX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79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TNNB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NCD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GNAQ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LMO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EK1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DGFR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B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OCS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TSH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XIN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C7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UL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NCE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GNAS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LRP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F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IK3C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BM10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OX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U2AF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XIN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H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XCR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NCG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GRIN2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LRP1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F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IK3C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ECQL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OX9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VEGF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XL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K1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YLD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NCM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3F3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LZTR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FE2L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IK3CD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ET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PEN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VHL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2M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K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YP2D6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S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DAC9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AP2K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FI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IK3CG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HO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PINK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WEE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AP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K6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DAXX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T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GF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AP2K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FKBI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IK3R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ICTO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POP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WEE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ARD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K8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DDR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T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NF1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AP2K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OTCH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IK3R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NF4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PTA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WT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CL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KN1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DICER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AT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RAS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AP3K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OTCH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MS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OCK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RC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XPO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CL2L1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KN1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DNMT3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BXW7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HSP90AA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AP3K1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OTCH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OL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OCK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RSF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XRCC3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CL6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KN2A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DOT1L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GFR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IDH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CL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OTCH4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OLD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OS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SX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ZNF750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  <a:tr h="1508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BCO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DKN2B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DPYD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FGFR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IDH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DM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NPM1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POLE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RPTOR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STAG2</a:t>
                      </a: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 Unicode MS"/>
                      </a:endParaRPr>
                    </a:p>
                  </a:txBody>
                  <a:tcPr marL="6858" marR="6858" marT="68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9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755576" y="389541"/>
            <a:ext cx="4999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. Table 1. The 329 ctDNA targeting gene list.</a:t>
            </a:r>
            <a:endParaRPr lang="zh-CN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37855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8936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136</TotalTime>
  <Words>528</Words>
  <Application>Microsoft Office PowerPoint</Application>
  <PresentationFormat>全屏显示(4:3)</PresentationFormat>
  <Paragraphs>345</Paragraphs>
  <Slides>5</Slides>
  <Notes>5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曾燕舞</dc:creator>
  <cp:lastModifiedBy>aa</cp:lastModifiedBy>
  <cp:revision>497</cp:revision>
  <dcterms:created xsi:type="dcterms:W3CDTF">2018-11-28T06:39:19Z</dcterms:created>
  <dcterms:modified xsi:type="dcterms:W3CDTF">2019-08-16T00:48:19Z</dcterms:modified>
</cp:coreProperties>
</file>